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12192000" cy="1371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72" y="-38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244726"/>
            <a:ext cx="10363200" cy="4775200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204076"/>
            <a:ext cx="9144000" cy="3311524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42880-CB23-41DB-96FC-BDEAE489423C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66BE-D994-441D-99D2-353F5AEBB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2845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42880-CB23-41DB-96FC-BDEAE489423C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66BE-D994-441D-99D2-353F5AEBB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376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30250"/>
            <a:ext cx="2628900" cy="1162367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30250"/>
            <a:ext cx="7734300" cy="1162367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42880-CB23-41DB-96FC-BDEAE489423C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66BE-D994-441D-99D2-353F5AEBB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575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42880-CB23-41DB-96FC-BDEAE489423C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66BE-D994-441D-99D2-353F5AEBB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8023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419479"/>
            <a:ext cx="10515600" cy="5705474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178929"/>
            <a:ext cx="10515600" cy="3000374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42880-CB23-41DB-96FC-BDEAE489423C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66BE-D994-441D-99D2-353F5AEBB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764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651250"/>
            <a:ext cx="5181600" cy="870267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651250"/>
            <a:ext cx="5181600" cy="870267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42880-CB23-41DB-96FC-BDEAE489423C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66BE-D994-441D-99D2-353F5AEBB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947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30253"/>
            <a:ext cx="10515600" cy="265112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362326"/>
            <a:ext cx="5157787" cy="164782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010150"/>
            <a:ext cx="5157787" cy="736917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362326"/>
            <a:ext cx="5183188" cy="1647824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010150"/>
            <a:ext cx="5183188" cy="736917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42880-CB23-41DB-96FC-BDEAE489423C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66BE-D994-441D-99D2-353F5AEBB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283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42880-CB23-41DB-96FC-BDEAE489423C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66BE-D994-441D-99D2-353F5AEBB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39656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42880-CB23-41DB-96FC-BDEAE489423C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66BE-D994-441D-99D2-353F5AEBB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4550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14400"/>
            <a:ext cx="3932237" cy="32004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974853"/>
            <a:ext cx="6172200" cy="9747250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114800"/>
            <a:ext cx="3932237" cy="762317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42880-CB23-41DB-96FC-BDEAE489423C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66BE-D994-441D-99D2-353F5AEBB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4531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14400"/>
            <a:ext cx="3932237" cy="32004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974853"/>
            <a:ext cx="6172200" cy="9747250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114800"/>
            <a:ext cx="3932237" cy="7623176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442880-CB23-41DB-96FC-BDEAE489423C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0066BE-D994-441D-99D2-353F5AEBB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489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30253"/>
            <a:ext cx="105156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651250"/>
            <a:ext cx="105156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2712703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442880-CB23-41DB-96FC-BDEAE489423C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2712703"/>
            <a:ext cx="2743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0066BE-D994-441D-99D2-353F5AEBB0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773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28749">
            <a:extLst>
              <a:ext uri="{FF2B5EF4-FFF2-40B4-BE49-F238E27FC236}">
                <a16:creationId xmlns:a16="http://schemas.microsoft.com/office/drawing/2014/main" id="{2AEDAF8C-2D20-A272-8451-01D3E92891EB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539398" y="6624498"/>
            <a:ext cx="4063478" cy="5372334"/>
          </a:xfrm>
          <a:prstGeom prst="rect">
            <a:avLst/>
          </a:prstGeom>
        </p:spPr>
      </p:pic>
      <p:pic>
        <p:nvPicPr>
          <p:cNvPr id="12" name="Picture 28754">
            <a:extLst>
              <a:ext uri="{FF2B5EF4-FFF2-40B4-BE49-F238E27FC236}">
                <a16:creationId xmlns:a16="http://schemas.microsoft.com/office/drawing/2014/main" id="{2D659BA9-199D-B597-22D0-7B3416A89ADB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6632140" y="6624498"/>
            <a:ext cx="4063478" cy="537233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F9378B7-5CBC-42BE-3CE0-D14CE4E2F59C}"/>
              </a:ext>
            </a:extLst>
          </p:cNvPr>
          <p:cNvSpPr txBox="1"/>
          <p:nvPr/>
        </p:nvSpPr>
        <p:spPr>
          <a:xfrm>
            <a:off x="1104557" y="6419484"/>
            <a:ext cx="295017" cy="5647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070" b="1" dirty="0"/>
              <a:t>C</a:t>
            </a:r>
            <a:endParaRPr lang="ko-KR" altLang="en-US" sz="307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EABC24E-8654-46BB-453F-665EAC4C8454}"/>
              </a:ext>
            </a:extLst>
          </p:cNvPr>
          <p:cNvSpPr txBox="1"/>
          <p:nvPr/>
        </p:nvSpPr>
        <p:spPr>
          <a:xfrm>
            <a:off x="6183709" y="6419484"/>
            <a:ext cx="295017" cy="5647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070" b="1" dirty="0"/>
              <a:t>D</a:t>
            </a:r>
            <a:endParaRPr lang="ko-KR" altLang="en-US" sz="3070" dirty="0"/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5F6F41F6-81DC-97F3-2558-7420F46BC54E}"/>
              </a:ext>
            </a:extLst>
          </p:cNvPr>
          <p:cNvSpPr/>
          <p:nvPr/>
        </p:nvSpPr>
        <p:spPr>
          <a:xfrm>
            <a:off x="2089780" y="6327012"/>
            <a:ext cx="259013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 err="1">
                <a:latin typeface="Calibri" panose="020F050202020403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thoxydimethylphenylsilane</a:t>
            </a:r>
            <a:endParaRPr lang="en-US" sz="1600" b="1" dirty="0"/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039458B9-89D7-CC06-5F0B-4F319660B145}"/>
              </a:ext>
            </a:extLst>
          </p:cNvPr>
          <p:cNvSpPr/>
          <p:nvPr/>
        </p:nvSpPr>
        <p:spPr>
          <a:xfrm>
            <a:off x="7155264" y="6333475"/>
            <a:ext cx="293881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ara-anisaldehyde diethyl acetal</a:t>
            </a:r>
            <a:endParaRPr lang="en-US" sz="1600" b="1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C33AC5D-9F9A-D5AC-FC3A-697FEA79E280}"/>
              </a:ext>
            </a:extLst>
          </p:cNvPr>
          <p:cNvSpPr txBox="1"/>
          <p:nvPr/>
        </p:nvSpPr>
        <p:spPr>
          <a:xfrm>
            <a:off x="9461635" y="-3049668"/>
            <a:ext cx="295017" cy="5647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070" b="1" dirty="0"/>
              <a:t>A</a:t>
            </a:r>
            <a:endParaRPr lang="ko-KR" altLang="en-US" sz="307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F2475F7-B1F8-2D3F-5DAC-C7A0DC617F5A}"/>
              </a:ext>
            </a:extLst>
          </p:cNvPr>
          <p:cNvSpPr txBox="1"/>
          <p:nvPr/>
        </p:nvSpPr>
        <p:spPr>
          <a:xfrm>
            <a:off x="14536234" y="-3049668"/>
            <a:ext cx="295017" cy="5647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070" b="1" dirty="0"/>
              <a:t>B</a:t>
            </a:r>
            <a:endParaRPr lang="ko-KR" altLang="en-US" sz="3070" dirty="0"/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0B65AD97-46A9-191A-069D-165CE9FA7405}"/>
              </a:ext>
            </a:extLst>
          </p:cNvPr>
          <p:cNvSpPr/>
          <p:nvPr/>
        </p:nvSpPr>
        <p:spPr>
          <a:xfrm>
            <a:off x="11528742" y="-3090381"/>
            <a:ext cx="692818" cy="2563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6" b="1" dirty="0">
                <a:latin typeface="Calibri" panose="020F050202020403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nethole</a:t>
            </a:r>
            <a:endParaRPr lang="en-US" sz="1066" b="1" dirty="0"/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E3935EF9-F13B-C085-F397-2205B7C6A299}"/>
              </a:ext>
            </a:extLst>
          </p:cNvPr>
          <p:cNvSpPr/>
          <p:nvPr/>
        </p:nvSpPr>
        <p:spPr>
          <a:xfrm>
            <a:off x="15931337" y="-3090675"/>
            <a:ext cx="2191626" cy="2563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66" b="1" dirty="0">
                <a:latin typeface="Calibri" panose="020F050202020403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1-(4-methoxyphenyl)-2-propanone </a:t>
            </a:r>
            <a:endParaRPr lang="en-US" sz="1066" b="1" dirty="0"/>
          </a:p>
        </p:txBody>
      </p:sp>
      <p:pic>
        <p:nvPicPr>
          <p:cNvPr id="25" name="Picture 28744">
            <a:extLst>
              <a:ext uri="{FF2B5EF4-FFF2-40B4-BE49-F238E27FC236}">
                <a16:creationId xmlns:a16="http://schemas.microsoft.com/office/drawing/2014/main" id="{65C2C17B-55F5-D46D-149B-2521CF84DABD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6623679" y="522637"/>
            <a:ext cx="4066299" cy="5372334"/>
          </a:xfrm>
          <a:prstGeom prst="rect">
            <a:avLst/>
          </a:prstGeom>
        </p:spPr>
      </p:pic>
      <p:pic>
        <p:nvPicPr>
          <p:cNvPr id="26" name="Picture 28739">
            <a:extLst>
              <a:ext uri="{FF2B5EF4-FFF2-40B4-BE49-F238E27FC236}">
                <a16:creationId xmlns:a16="http://schemas.microsoft.com/office/drawing/2014/main" id="{B72B2FA9-933D-B72D-1EC5-7D0D0C17A082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>
          <a:xfrm>
            <a:off x="1536575" y="522637"/>
            <a:ext cx="4066299" cy="5372334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EC33AC5D-9F9A-D5AC-FC3A-697FEA79E280}"/>
              </a:ext>
            </a:extLst>
          </p:cNvPr>
          <p:cNvSpPr txBox="1"/>
          <p:nvPr/>
        </p:nvSpPr>
        <p:spPr>
          <a:xfrm>
            <a:off x="1104557" y="317623"/>
            <a:ext cx="295017" cy="5647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070" b="1" dirty="0"/>
              <a:t>A</a:t>
            </a:r>
            <a:endParaRPr lang="ko-KR" altLang="en-US" sz="307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F2475F7-B1F8-2D3F-5DAC-C7A0DC617F5A}"/>
              </a:ext>
            </a:extLst>
          </p:cNvPr>
          <p:cNvSpPr txBox="1"/>
          <p:nvPr/>
        </p:nvSpPr>
        <p:spPr>
          <a:xfrm>
            <a:off x="6179157" y="317623"/>
            <a:ext cx="295017" cy="5647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3070" b="1" dirty="0"/>
              <a:t>B</a:t>
            </a:r>
            <a:endParaRPr lang="ko-KR" altLang="en-US" sz="3070" dirty="0"/>
          </a:p>
        </p:txBody>
      </p:sp>
      <p:sp>
        <p:nvSpPr>
          <p:cNvPr id="29" name="직사각형 28">
            <a:extLst>
              <a:ext uri="{FF2B5EF4-FFF2-40B4-BE49-F238E27FC236}">
                <a16:creationId xmlns:a16="http://schemas.microsoft.com/office/drawing/2014/main" id="{0B65AD97-46A9-191A-069D-165CE9FA7405}"/>
              </a:ext>
            </a:extLst>
          </p:cNvPr>
          <p:cNvSpPr/>
          <p:nvPr/>
        </p:nvSpPr>
        <p:spPr>
          <a:xfrm>
            <a:off x="2740344" y="225151"/>
            <a:ext cx="94147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nethole</a:t>
            </a:r>
            <a:endParaRPr lang="en-US" sz="1600" b="1" dirty="0"/>
          </a:p>
        </p:txBody>
      </p:sp>
      <p:sp>
        <p:nvSpPr>
          <p:cNvPr id="30" name="직사각형 29">
            <a:extLst>
              <a:ext uri="{FF2B5EF4-FFF2-40B4-BE49-F238E27FC236}">
                <a16:creationId xmlns:a16="http://schemas.microsoft.com/office/drawing/2014/main" id="{E3935EF9-F13B-C085-F397-2205B7C6A299}"/>
              </a:ext>
            </a:extLst>
          </p:cNvPr>
          <p:cNvSpPr/>
          <p:nvPr/>
        </p:nvSpPr>
        <p:spPr>
          <a:xfrm>
            <a:off x="7142939" y="224857"/>
            <a:ext cx="318657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600" b="1" dirty="0">
                <a:latin typeface="Calibri" panose="020F050202020403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1-(4-methoxyphenyl)-2-propanone </a:t>
            </a:r>
            <a:endParaRPr lang="en-US" sz="1600" b="1" dirty="0"/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1ADFC3CE-2A29-4F2A-9E62-6D5B1605AD5F}"/>
              </a:ext>
            </a:extLst>
          </p:cNvPr>
          <p:cNvSpPr/>
          <p:nvPr/>
        </p:nvSpPr>
        <p:spPr>
          <a:xfrm>
            <a:off x="134605" y="12056239"/>
            <a:ext cx="11922790" cy="15615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kern="1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 Figure 2. The MS fragmentation patterns and their matches to the NIST 12.0 spectral library. The GC-MS analysis was performed as described in section 2.10, "Gas Chromatography-Mass Spectrometry (GC-MS) Analysis," in the Materials and Methods. The spectrum of fragment ions with specific mass-to-charge ratios (m/z) and their intensities for each phytochemical peak was searched against the NIST (National Institute of Standards and Technology) 12.0 spectral library.</a:t>
            </a:r>
          </a:p>
        </p:txBody>
      </p:sp>
    </p:spTree>
    <p:extLst>
      <p:ext uri="{BB962C8B-B14F-4D97-AF65-F5344CB8AC3E}">
        <p14:creationId xmlns:p14="http://schemas.microsoft.com/office/powerpoint/2010/main" val="80998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</TotalTime>
  <Words>104</Words>
  <Application>Microsoft Office PowerPoint</Application>
  <PresentationFormat>사용자 지정</PresentationFormat>
  <Paragraphs>1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Palatino Linotype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oonIS</cp:lastModifiedBy>
  <cp:revision>5</cp:revision>
  <dcterms:created xsi:type="dcterms:W3CDTF">2024-09-13T03:09:19Z</dcterms:created>
  <dcterms:modified xsi:type="dcterms:W3CDTF">2024-09-25T01:33:29Z</dcterms:modified>
</cp:coreProperties>
</file>